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E2EE1-AB09-4594-A17C-653DC972CA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7736A-5E29-4990-9422-EC1A87AF8A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F5A83-F9BE-46C9-B8F9-818D996DCB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6935F5-642E-4EBD-B627-EF4DB4DDA5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759E9-2D4E-4A48-AF51-6E55CBFA76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3D44E-A348-41CE-8D9C-3F4EF020E6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EF40E-088F-4F9D-8A83-94756BDEFA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AD8FF-87E8-4A9A-85B5-A25AB72D9C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80A30-9D8E-4F57-83AB-A327E01AC8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9190F-C772-4070-8334-5A2AB6A695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2CD1E-F05F-4525-992F-0C5C49675A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0C5C4-875F-454D-B6B0-C8A4D39A57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AFE7D8-3E84-40F8-86FC-532DE7C1C83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003400" y="1374840"/>
            <a:ext cx="2577960" cy="26924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 flipH="1">
            <a:off x="3573000" y="2122560"/>
            <a:ext cx="1079640" cy="331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653000" y="1881360"/>
            <a:ext cx="1081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ytokera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ositiv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844640" y="2193840"/>
            <a:ext cx="1008000" cy="331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123920" y="1951200"/>
            <a:ext cx="79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egative contr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6" name=""/>
          <p:cNvGraphicFramePr/>
          <p:nvPr/>
        </p:nvGraphicFramePr>
        <p:xfrm>
          <a:off x="1197000" y="4654440"/>
          <a:ext cx="4572000" cy="2365560"/>
        </p:xfrm>
        <a:graphic>
          <a:graphicData uri="http://schemas.openxmlformats.org/drawingml/2006/table">
            <a:tbl>
              <a:tblPr/>
              <a:tblGrid>
                <a:gridCol w="1523880"/>
                <a:gridCol w="1524240"/>
                <a:gridCol w="1523880"/>
              </a:tblGrid>
              <a:tr h="549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ithelial cell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tokera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.8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606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ibroblast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ment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.08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1.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04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dothelial cell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5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± 0.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048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crophage and inflammatory cell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D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 detectab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7" name=""/>
          <p:cNvSpPr/>
          <p:nvPr/>
        </p:nvSpPr>
        <p:spPr>
          <a:xfrm>
            <a:off x="1369080" y="434016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807280" y="4338720"/>
            <a:ext cx="76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k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076640" y="4338720"/>
            <a:ext cx="150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% of positive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1622520" y="246276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333399"/>
                </a:solidFill>
                <a:latin typeface="Arial"/>
              </a:rPr>
              <a:t>Cou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824040" y="468360"/>
            <a:ext cx="4827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l Figure 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haracterization of isolated alveolar epithelial cells by flow cytomet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0T15:41:43Z</dcterms:created>
  <dc:creator>bss3jl</dc:creator>
  <dc:description/>
  <dc:language>en-US</dc:language>
  <cp:lastModifiedBy>bss3jl</cp:lastModifiedBy>
  <dcterms:modified xsi:type="dcterms:W3CDTF">2011-05-05T16:25:08Z</dcterms:modified>
  <cp:revision>5</cp:revision>
  <dc:subject/>
  <dc:title>Slide 1</dc:title>
</cp:coreProperties>
</file>